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2"/>
    <p:restoredTop sz="96925"/>
  </p:normalViewPr>
  <p:slideViewPr>
    <p:cSldViewPr snapToGrid="0" snapToObjects="1">
      <p:cViewPr varScale="1">
        <p:scale>
          <a:sx n="107" d="100"/>
          <a:sy n="107" d="100"/>
        </p:scale>
        <p:origin x="33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4668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4519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6274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8957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862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4499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8531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1974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673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8262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4604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15FD3C-8137-2148-9998-7FEBDAC42368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1B110-2FCA-6E45-BC4F-28103EE5A9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0781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56A86757-4195-1545-9ABA-BFE65A52A468}"/>
              </a:ext>
            </a:extLst>
          </p:cNvPr>
          <p:cNvSpPr txBox="1"/>
          <p:nvPr/>
        </p:nvSpPr>
        <p:spPr>
          <a:xfrm>
            <a:off x="34804" y="227535"/>
            <a:ext cx="67068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. Abundance and closest sequence retrieved from Blast analysis for each of the three OTUs analysed through the MED pipeline</a:t>
            </a:r>
          </a:p>
        </p:txBody>
      </p:sp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07F6528A-87D6-A24B-A227-0619494E02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1275317"/>
              </p:ext>
            </p:extLst>
          </p:nvPr>
        </p:nvGraphicFramePr>
        <p:xfrm>
          <a:off x="125413" y="782143"/>
          <a:ext cx="6677025" cy="1230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Feuille de calcul" r:id="rId3" imgW="11379200" imgH="2095500" progId="Excel.Sheet.12">
                  <p:embed/>
                </p:oleObj>
              </mc:Choice>
              <mc:Fallback>
                <p:oleObj name="Feuille de calcul" r:id="rId3" imgW="11379200" imgH="2095500" progId="Excel.Sheet.12">
                  <p:embed/>
                  <p:pic>
                    <p:nvPicPr>
                      <p:cNvPr id="51" name="Objet 50">
                        <a:extLst>
                          <a:ext uri="{FF2B5EF4-FFF2-40B4-BE49-F238E27FC236}">
                            <a16:creationId xmlns:a16="http://schemas.microsoft.com/office/drawing/2014/main" id="{CC566CAC-061D-7F4C-9D05-29AFC78D4A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5413" y="782143"/>
                        <a:ext cx="6677025" cy="1230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45F08016-F745-EA41-84E5-7BEA1BE46D40}"/>
              </a:ext>
            </a:extLst>
          </p:cNvPr>
          <p:cNvSpPr txBox="1"/>
          <p:nvPr/>
        </p:nvSpPr>
        <p:spPr>
          <a:xfrm>
            <a:off x="0" y="2177282"/>
            <a:ext cx="674167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(1) Bowman JP,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cCuaig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RD: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odiversit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mmunit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structural shifts, and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ogeograph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okaryote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tarcti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continental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elf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diment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pl</a:t>
            </a:r>
            <a:r>
              <a:rPr lang="fr-FR" sz="1200" i="1" dirty="0">
                <a:latin typeface="Arial" panose="020B0604020202020204" pitchFamily="34" charset="0"/>
                <a:cs typeface="Arial" panose="020B0604020202020204" pitchFamily="34" charset="0"/>
              </a:rPr>
              <a:t> Environ </a:t>
            </a:r>
            <a:r>
              <a:rPr lang="fr-F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crobiol</a:t>
            </a:r>
            <a:r>
              <a:rPr lang="fr-F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2003, 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69: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2463-2483. </a:t>
            </a:r>
          </a:p>
          <a:p>
            <a:pPr>
              <a:spcBef>
                <a:spcPts val="600"/>
              </a:spcBef>
            </a:pP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(2) Acosta‐González A,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Rosselló‐Móra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R, Marqués S: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aracterization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erobi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icrobia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mmunit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il‐pollu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btida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diment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romati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odegradation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otentia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the Prestige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il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Environmental</a:t>
            </a:r>
            <a:r>
              <a:rPr lang="fr-F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icrobiology</a:t>
            </a:r>
            <a:r>
              <a:rPr lang="fr-F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2013, 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15: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77-92. </a:t>
            </a:r>
          </a:p>
        </p:txBody>
      </p:sp>
    </p:spTree>
    <p:extLst>
      <p:ext uri="{BB962C8B-B14F-4D97-AF65-F5344CB8AC3E}">
        <p14:creationId xmlns:p14="http://schemas.microsoft.com/office/powerpoint/2010/main" val="40070054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9</Words>
  <Application>Microsoft Macintosh PowerPoint</Application>
  <PresentationFormat>Format A4 (210 x 297 mm)</PresentationFormat>
  <Paragraphs>3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Feuille de calcul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Guillaume</cp:lastModifiedBy>
  <cp:revision>3</cp:revision>
  <cp:lastPrinted>2020-12-22T17:29:44Z</cp:lastPrinted>
  <dcterms:created xsi:type="dcterms:W3CDTF">2020-12-22T17:29:27Z</dcterms:created>
  <dcterms:modified xsi:type="dcterms:W3CDTF">2020-12-23T18:43:00Z</dcterms:modified>
</cp:coreProperties>
</file>